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4690"/>
  </p:normalViewPr>
  <p:slideViewPr>
    <p:cSldViewPr snapToGrid="0" snapToObjects="1">
      <p:cViewPr varScale="1">
        <p:scale>
          <a:sx n="100" d="100"/>
          <a:sy n="100" d="100"/>
        </p:scale>
        <p:origin x="464" y="1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7D726A-806A-2946-B06B-00D225A47BC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5D9D546-E993-8247-9FB0-09CEBC28F03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0175E9-C75A-AF44-9F60-505F1AA052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E8304-CF44-6A4F-9452-EED08FBE221E}" type="datetimeFigureOut">
              <a:rPr lang="en-US" smtClean="0"/>
              <a:t>7/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7CC83C-B0AF-B946-BE42-445CC418AC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D05031-2CCF-8E41-9F91-126EFADD55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F2451D-CAC7-8B40-940D-E5991921F6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90502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E01019-9337-144C-9604-1A01B7C594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174F6E1-D3D6-504F-973F-0594C43021F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859940-B86A-0942-B210-8EF11F7F2A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E8304-CF44-6A4F-9452-EED08FBE221E}" type="datetimeFigureOut">
              <a:rPr lang="en-US" smtClean="0"/>
              <a:t>7/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8C9329-6FDF-6542-8A63-2016451932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6E8BF6-A5F8-0F45-A381-DFBE44EC91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F2451D-CAC7-8B40-940D-E5991921F6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94335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BCFD948-1B20-3B4D-8E35-2E45F755F55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1B204A3-72D7-0E42-811A-D463325E37E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805822-B430-6440-90A0-BE4F9BE38E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E8304-CF44-6A4F-9452-EED08FBE221E}" type="datetimeFigureOut">
              <a:rPr lang="en-US" smtClean="0"/>
              <a:t>7/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242F88-A962-1D43-A70B-9923FC9057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F6A5E0-D3BD-6E4A-86E4-1FC324EA05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F2451D-CAC7-8B40-940D-E5991921F6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86908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392E2D-165E-7E42-AD54-0A0181FAE7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EA9FCA8-9BE9-1E4C-BB34-38DAB1F21FA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2B4352-739C-3946-95A6-2B9E3F81FB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E8304-CF44-6A4F-9452-EED08FBE221E}" type="datetimeFigureOut">
              <a:rPr lang="en-US" smtClean="0"/>
              <a:t>7/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17E66D-89FB-844F-BC72-169B023485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AB374F-991A-6642-AB5E-173913ABD6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F2451D-CAC7-8B40-940D-E5991921F6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57616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6C0AA4-A370-784B-9D0A-A6260C755B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1375FAE-A23B-D047-8A1B-B13A15E7A8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64A2A4-6281-6849-8127-F3E5FF9FB8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E8304-CF44-6A4F-9452-EED08FBE221E}" type="datetimeFigureOut">
              <a:rPr lang="en-US" smtClean="0"/>
              <a:t>7/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5FE957-75A4-CB4D-A95F-6D2393BE2C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836553-D7E4-C54C-971B-A3A9D03716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F2451D-CAC7-8B40-940D-E5991921F6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78915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4F5AF3-C52E-6F4A-A155-77951019FC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384B1D5-BCB1-824A-BE2E-2615EB2D5F4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932CFC3-FC06-CE45-BB49-1153B34F409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0C8A042-FFD7-3D4E-A0EA-4B5E11067D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E8304-CF44-6A4F-9452-EED08FBE221E}" type="datetimeFigureOut">
              <a:rPr lang="en-US" smtClean="0"/>
              <a:t>7/1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58EC0B8-DC99-3E4E-A6C3-D3DFB6D27A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30702F2-CD52-4147-BB2C-6781F0D9E3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F2451D-CAC7-8B40-940D-E5991921F6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03996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E77CDC-0CE9-0D40-9527-A66900FCF9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B8E0B5A-CFC3-0641-A8B3-33A70A1222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DCE099A-6CE9-4E40-9E1A-1AE4E3071C7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DDAAE9D-19B2-9648-945F-1332810CA80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6436ABA-6E16-B34B-B41C-8515C911564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FD38D9D-E7A8-6E48-9345-B8CB9D1F96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E8304-CF44-6A4F-9452-EED08FBE221E}" type="datetimeFigureOut">
              <a:rPr lang="en-US" smtClean="0"/>
              <a:t>7/1/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6855C83-24B2-E24A-8491-3D75E87A8D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7BDEFAF-19D3-FE4F-B2C4-8B1E7B7BDE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F2451D-CAC7-8B40-940D-E5991921F6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74584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AC6E17-D43A-6142-9344-20FD14C333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9F6BF03-9DD8-3D43-9D2A-05866C2612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E8304-CF44-6A4F-9452-EED08FBE221E}" type="datetimeFigureOut">
              <a:rPr lang="en-US" smtClean="0"/>
              <a:t>7/1/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F7D952B-E923-2A4F-8C34-EE6B068B81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9C2E2DE-9ABF-B448-B554-5E08B67B5E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F2451D-CAC7-8B40-940D-E5991921F6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39524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757C714-B348-2140-A612-4DD5509891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E8304-CF44-6A4F-9452-EED08FBE221E}" type="datetimeFigureOut">
              <a:rPr lang="en-US" smtClean="0"/>
              <a:t>7/1/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C81AA48-D860-7846-BAEB-92297CA4F0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CACB89D-4709-D341-B81A-BEB8A4C5A5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F2451D-CAC7-8B40-940D-E5991921F6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80751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A68C8B-C04B-984C-9CD6-97C2B4EBD6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14FC8EE-B0FE-CC49-9FC1-54A76303EB8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3BDD83A-87EB-BB4B-9986-8F41A1AEA61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049E5C8-F4EA-0748-AA58-EA3495E489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E8304-CF44-6A4F-9452-EED08FBE221E}" type="datetimeFigureOut">
              <a:rPr lang="en-US" smtClean="0"/>
              <a:t>7/1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BBABBB1-A6E8-4A4C-8DA6-5338F67BEB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6B5B74C-366C-5F4E-9A39-904AA001F0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F2451D-CAC7-8B40-940D-E5991921F6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98739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735B6F-1B3B-5544-93AB-D077535EC3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9A6E966-3284-284B-95EB-616E6A78AFB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ED59DEA-2726-BD4D-9602-BCBB33E6694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F8E407F-94B2-4844-970A-98A2927A25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E8304-CF44-6A4F-9452-EED08FBE221E}" type="datetimeFigureOut">
              <a:rPr lang="en-US" smtClean="0"/>
              <a:t>7/1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53D4AA-F5F5-2947-AB58-15AFE762BA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3E21D6B-530A-AB4C-9434-14DB3F461D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F2451D-CAC7-8B40-940D-E5991921F6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46858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AECC190-9F15-CF4A-97E9-27E5276D18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1A150DC-96B1-FC48-8C89-D57FFE2F41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3EED77-8421-7D4A-A113-D59840E4C6F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0E8304-CF44-6A4F-9452-EED08FBE221E}" type="datetimeFigureOut">
              <a:rPr lang="en-US" smtClean="0"/>
              <a:t>7/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20A2B5-997E-3748-AFA4-37361213DE3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811A5B-C3E5-FF44-A72B-50DA1E04A10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F2451D-CAC7-8B40-940D-E5991921F6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20929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1045BCFF-148A-9945-BE4C-E53FDD31AD0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73650282"/>
              </p:ext>
            </p:extLst>
          </p:nvPr>
        </p:nvGraphicFramePr>
        <p:xfrm>
          <a:off x="1366353" y="1011031"/>
          <a:ext cx="5741229" cy="3028397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774114">
                  <a:extLst>
                    <a:ext uri="{9D8B030D-6E8A-4147-A177-3AD203B41FA5}">
                      <a16:colId xmlns:a16="http://schemas.microsoft.com/office/drawing/2014/main" val="683994124"/>
                    </a:ext>
                  </a:extLst>
                </a:gridCol>
                <a:gridCol w="776175">
                  <a:extLst>
                    <a:ext uri="{9D8B030D-6E8A-4147-A177-3AD203B41FA5}">
                      <a16:colId xmlns:a16="http://schemas.microsoft.com/office/drawing/2014/main" val="1162775086"/>
                    </a:ext>
                  </a:extLst>
                </a:gridCol>
                <a:gridCol w="1232023">
                  <a:extLst>
                    <a:ext uri="{9D8B030D-6E8A-4147-A177-3AD203B41FA5}">
                      <a16:colId xmlns:a16="http://schemas.microsoft.com/office/drawing/2014/main" val="2008409192"/>
                    </a:ext>
                  </a:extLst>
                </a:gridCol>
                <a:gridCol w="887057">
                  <a:extLst>
                    <a:ext uri="{9D8B030D-6E8A-4147-A177-3AD203B41FA5}">
                      <a16:colId xmlns:a16="http://schemas.microsoft.com/office/drawing/2014/main" val="2300526569"/>
                    </a:ext>
                  </a:extLst>
                </a:gridCol>
                <a:gridCol w="1071860">
                  <a:extLst>
                    <a:ext uri="{9D8B030D-6E8A-4147-A177-3AD203B41FA5}">
                      <a16:colId xmlns:a16="http://schemas.microsoft.com/office/drawing/2014/main" val="3725829125"/>
                    </a:ext>
                  </a:extLst>
                </a:gridCol>
              </a:tblGrid>
              <a:tr h="365401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mune Group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assical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senchymal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neural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</a:t>
                      </a:r>
                      <a:endParaRPr lang="en-GB" sz="12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52102813"/>
                  </a:ext>
                </a:extLst>
              </a:tr>
              <a:tr h="365401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C1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GB" sz="12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45082275"/>
                  </a:ext>
                </a:extLst>
              </a:tr>
              <a:tr h="365401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C2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8465993"/>
                  </a:ext>
                </a:extLst>
              </a:tr>
              <a:tr h="365401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C3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40092571"/>
                  </a:ext>
                </a:extLst>
              </a:tr>
              <a:tr h="47059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C4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89895245"/>
                  </a:ext>
                </a:extLst>
              </a:tr>
              <a:tr h="365401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C5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242043149"/>
                  </a:ext>
                </a:extLst>
              </a:tr>
              <a:tr h="365401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C6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27149563"/>
                  </a:ext>
                </a:extLst>
              </a:tr>
              <a:tr h="365401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</a:t>
                      </a:r>
                      <a:endParaRPr lang="en-GB" sz="12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</a:t>
                      </a:r>
                      <a:endParaRPr lang="en-GB" sz="12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</a:t>
                      </a:r>
                      <a:endParaRPr lang="en-GB" sz="12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7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87171520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027935" y="4307409"/>
            <a:ext cx="584880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he number of TCGA patient tumours classified into each GBM expression subtype per immune group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 chi-squared test on the distributions within the largest immune groups,  CIC2 and CIC4, show that these are significantly different (p=3.8x10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-7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, with the mesenchymal subtype enriched in the former and depleted in the latter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E19F3A5-A4D6-1B48-AFCC-30580F26AD27}"/>
              </a:ext>
            </a:extLst>
          </p:cNvPr>
          <p:cNvSpPr txBox="1"/>
          <p:nvPr/>
        </p:nvSpPr>
        <p:spPr>
          <a:xfrm>
            <a:off x="1027935" y="323043"/>
            <a:ext cx="18580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2</a:t>
            </a:r>
          </a:p>
        </p:txBody>
      </p:sp>
    </p:spTree>
    <p:extLst>
      <p:ext uri="{BB962C8B-B14F-4D97-AF65-F5344CB8AC3E}">
        <p14:creationId xmlns:p14="http://schemas.microsoft.com/office/powerpoint/2010/main" val="31623951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36</TotalTime>
  <Words>100</Words>
  <Application>Microsoft Macintosh PowerPoint</Application>
  <PresentationFormat>Widescreen</PresentationFormat>
  <Paragraphs>4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5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 table 4 Chi square data from Lucy.</dc:title>
  <dc:creator>Graham Cook</dc:creator>
  <cp:lastModifiedBy>Erica Watson</cp:lastModifiedBy>
  <cp:revision>6</cp:revision>
  <dcterms:created xsi:type="dcterms:W3CDTF">2018-10-15T16:33:12Z</dcterms:created>
  <dcterms:modified xsi:type="dcterms:W3CDTF">2019-07-01T14:50:52Z</dcterms:modified>
</cp:coreProperties>
</file>